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32" userDrawn="1">
          <p15:clr>
            <a:srgbClr val="A4A3A4"/>
          </p15:clr>
        </p15:guide>
        <p15:guide id="2" pos="1272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F2DD5FA-67A6-AEAD-2C92-E8FAA7FAA041}" name="Drorit Neumann" initials="DN" userId="S::histo6@tauex.tau.ac.il::48e618ba-376d-47b2-9539-36daa82f59e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59" d="100"/>
          <a:sy n="59" d="100"/>
        </p:scale>
        <p:origin x="76" y="76"/>
      </p:cViewPr>
      <p:guideLst>
        <p:guide orient="horz" pos="2232"/>
        <p:guide pos="127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E76AAF-5084-C622-2BD5-CD32CF1E898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7E4CE29-081D-3C62-582D-7533CD83737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F640595-9CC1-A7CC-FC71-F96898B0BA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B9C1A3-DEAB-0C00-486C-190DDF806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8A91EE-9613-4AB7-BBFD-417134BA9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5553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DC410B-BFDA-B2BD-E4FE-8D4DDD5850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3B229A-4624-CF4D-4CEB-8F572F3FC8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452EF8-3985-BE10-4696-A4A2E2A7E8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05B4E0E-F26F-B2E7-6CEE-C37E2C762C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6CD211-DCA7-B425-EE0E-42636DBBC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2185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4A80D8-5C7D-1CDF-8429-C12408F8D95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970450B-69E6-7E86-6C1B-EAE7A762D3C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2CC6EA-93AA-779A-6D81-C7343CD25D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F281AE-C6EA-ED08-9980-A3281EC44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944F99-CA8F-B4BF-B655-2643217BA8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96385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5CF4EA-3CFA-E06C-392A-8A6046B28D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E7A167-6DED-202F-5AA6-47E7B2E19E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A04CC3D-4246-8157-0F59-50395A060E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97AC08-D8BF-8F13-8C62-7BF542C4E1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D42A42-292D-AE89-DF81-1E69DA4110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523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4D963-646A-D5E4-AB3B-955E471386B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32A3A8-4191-75E1-144F-77AD70C0E5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8A7F3FE-31AA-AC6E-73E8-D0B844F581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90195E-74EE-9B63-0289-C0939B63B5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AAB5C8-9FFD-9270-2742-691C34475C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76906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E19C87-1EF9-B103-6FBA-330F52AAFC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2BFFB5F-EE09-995F-0B8B-77C0BA62B7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62457C-70DA-00BC-4626-5E865A3AC80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697ACDF-B775-9437-BDE7-04A9E9EA57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6F15097-7AE8-057F-2A9D-F83F7595C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B6DE13-27D8-6D45-84DE-4FA69B6B43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9542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F38F28-C6E3-AF17-0565-245FB6239A5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328562-33D4-C5F4-E2B6-BDE7F0DBB29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2600CB-BD35-104F-C9F4-3A0DF56160D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367D5A6-AC14-6963-4187-37E841066C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814ABCF-63CB-8448-41B2-53C506773A6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A0131FF-E805-5DFF-09EA-3404D202BE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81887F-CE89-6928-16E7-FE381E03BA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8AD2DCE-3C0D-2D58-C466-0A43039B8D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246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E89A82-6DF9-1A1E-DDC1-B5A998294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D39DCD5-8765-E597-6BFA-7CBB4F9706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CB43812-407A-EB36-23F8-79AA523D2C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00A718D-E1A0-80BF-0DDB-808525579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9271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A128699-8F32-B765-451A-7A7BB1D03A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FC56EA9-4DF0-6260-6E24-F92E82B11B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74EC76E-AB07-9895-48E7-5041C5D4AC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8771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0431DC-AF39-0D31-EE1C-FEA8B272B9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21FBEC0-8972-E5CA-D6CA-A65F7B2AE0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10298A-0A10-2FDA-981D-E2C21BD10D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81CFC8-1A97-B705-D05E-71FD260DFF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F9517E6-7882-57FB-D863-95E99329E5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86E169-538D-AD52-0DBE-0C0E69736A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18129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708713-7A5F-18AE-E69D-591BA111C4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B8B1CB-1FE8-5DF9-6D7A-9125498DBEC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574094-86EB-CE95-6547-3160176FC7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DFBC783-79C5-604A-202C-60D327022C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D4DD06-B335-9D7C-691F-BB5DF34555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16C8F7-0DCD-80D0-A207-01031A582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8584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14002C-A085-074B-D463-48997A731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C65B170-3286-C067-9E15-F4C3A10791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8B9D43-3A77-C428-4AF9-F9AE27E8CC0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51F645-C901-4EBB-A629-05F05DEBE834}" type="datetimeFigureOut">
              <a:rPr lang="en-US" smtClean="0"/>
              <a:t>10/8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3F67A5-7243-423A-34BF-4DAC4873D39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8BC97D1-4D32-FD6D-0D98-28A57349A62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C7EDA4-E2BF-4902-802E-896BB1BACE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28933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24A9050-B941-1B97-214D-43C6F2720EB4}"/>
              </a:ext>
            </a:extLst>
          </p:cNvPr>
          <p:cNvSpPr txBox="1"/>
          <p:nvPr/>
        </p:nvSpPr>
        <p:spPr>
          <a:xfrm>
            <a:off x="2028155" y="4661591"/>
            <a:ext cx="6832286" cy="1269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lnSpc>
                <a:spcPct val="107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igure S1. EPOR expression in TER119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rythroid cells and CD115</a:t>
            </a:r>
            <a:r>
              <a:rPr lang="en-US" sz="1200" b="1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steoclast precursors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a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POR expression as measured by RT-qPCR in bone marrow-derived TER119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115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ells from 12-week-old WT female mice. Expression of EPOR was normalized to HPRT, n=4. </a:t>
            </a:r>
            <a:r>
              <a:rPr lang="en-US" sz="1200" b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rface expression of EPOR by TER119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CD115</a:t>
            </a:r>
            <a:r>
              <a:rPr lang="en-US" sz="1200" baseline="300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ells of total bone marrow from 12-week-old WT female mice as measured by mean fluorescence intensity (MFI) using flow cytometry analysi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ti N-terminus EPOR antibody was used for this analysis, n=5. All data are mean ± SD, **p &lt; 0.01, student’s </a:t>
            </a:r>
            <a:r>
              <a:rPr lang="en-US" sz="1200" i="1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</a:t>
            </a:r>
            <a:r>
              <a:rPr lang="en-US" sz="12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test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2152287-8646-8387-7464-A6342B0071E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28155" y="683951"/>
            <a:ext cx="6747257" cy="39776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93207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118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amzam Awida</dc:creator>
  <cp:lastModifiedBy>Zamzam Awida</cp:lastModifiedBy>
  <cp:revision>7</cp:revision>
  <dcterms:created xsi:type="dcterms:W3CDTF">2022-09-29T08:18:59Z</dcterms:created>
  <dcterms:modified xsi:type="dcterms:W3CDTF">2022-10-08T20:54:06Z</dcterms:modified>
</cp:coreProperties>
</file>